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6858000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737"/>
  </p:normalViewPr>
  <p:slideViewPr>
    <p:cSldViewPr snapToGrid="0">
      <p:cViewPr varScale="1">
        <p:scale>
          <a:sx n="94" d="100"/>
          <a:sy n="94" d="100"/>
        </p:scale>
        <p:origin x="307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14125"/>
            <a:ext cx="5829300" cy="300826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538401"/>
            <a:ext cx="5143500" cy="208618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0651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7442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60041"/>
            <a:ext cx="1478756" cy="732264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60041"/>
            <a:ext cx="4350544" cy="732264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2737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0484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154193"/>
            <a:ext cx="5915025" cy="359431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782513"/>
            <a:ext cx="5915025" cy="189016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4865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00203"/>
            <a:ext cx="2914650" cy="54824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00203"/>
            <a:ext cx="2914650" cy="54824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6463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60043"/>
            <a:ext cx="5915025" cy="167014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118188"/>
            <a:ext cx="2901255" cy="103809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156278"/>
            <a:ext cx="2901255" cy="46424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118188"/>
            <a:ext cx="2915543" cy="103809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156278"/>
            <a:ext cx="2915543" cy="46424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45114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3087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85192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76051"/>
            <a:ext cx="2211884" cy="201617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44112"/>
            <a:ext cx="3471863" cy="614054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592229"/>
            <a:ext cx="2211884" cy="480242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5936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76051"/>
            <a:ext cx="2211884" cy="201617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44112"/>
            <a:ext cx="3471863" cy="614054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592229"/>
            <a:ext cx="2211884" cy="480242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800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60043"/>
            <a:ext cx="5915025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00203"/>
            <a:ext cx="5915025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008709"/>
            <a:ext cx="1543050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008709"/>
            <a:ext cx="2314575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008709"/>
            <a:ext cx="1543050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03359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AA814D1-948C-B7CE-7F23-3BD7C1636157}"/>
              </a:ext>
            </a:extLst>
          </p:cNvPr>
          <p:cNvSpPr txBox="1"/>
          <p:nvPr/>
        </p:nvSpPr>
        <p:spPr>
          <a:xfrm>
            <a:off x="697087" y="4711157"/>
            <a:ext cx="5463822" cy="30482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upplementary Figure S1 </a:t>
            </a:r>
            <a:endParaRPr lang="ja-JP" altLang="ja-JP" sz="1400" b="1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Elbow method for determining the optimal number of clusters. </a:t>
            </a:r>
          </a:p>
          <a:p>
            <a:pPr algn="l">
              <a:lnSpc>
                <a:spcPct val="200000"/>
              </a:lnSpc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The elbow method used to determine the optimal number of clusters for unsupervised agglomerative clustering. A distance matrix was constructed using Euclidean distance, and the within-cluster sum of squares was evaluated to identify the point at which the marginal gain decreased, indicating three as the optimal number of clusters.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DDA05492-9CBD-80F1-BF06-FE8067114E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719" y="419849"/>
            <a:ext cx="6398559" cy="41548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6208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0</TotalTime>
  <Words>66</Words>
  <Application>Microsoft Macintosh PowerPoint</Application>
  <PresentationFormat>ユーザー設定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oji yokobori</dc:creator>
  <cp:lastModifiedBy>Takiguchi Toru</cp:lastModifiedBy>
  <cp:revision>6</cp:revision>
  <dcterms:created xsi:type="dcterms:W3CDTF">2025-01-29T22:59:33Z</dcterms:created>
  <dcterms:modified xsi:type="dcterms:W3CDTF">2025-07-01T06:42:34Z</dcterms:modified>
</cp:coreProperties>
</file>